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6" r:id="rId2"/>
  </p:sldIdLst>
  <p:sldSz cx="12192000" cy="6858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78" d="100"/>
          <a:sy n="78" d="100"/>
        </p:scale>
        <p:origin x="186" y="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777C6-8BDF-4582-9500-7DF6310D3978}" type="datetimeFigureOut">
              <a:rPr lang="zh-CN" altLang="en-US" smtClean="0"/>
              <a:t>2022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2A26-D126-4290-B59C-AD18D371CC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49137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777C6-8BDF-4582-9500-7DF6310D3978}" type="datetimeFigureOut">
              <a:rPr lang="zh-CN" altLang="en-US" smtClean="0"/>
              <a:t>2022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2A26-D126-4290-B59C-AD18D371CC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6006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777C6-8BDF-4582-9500-7DF6310D3978}" type="datetimeFigureOut">
              <a:rPr lang="zh-CN" altLang="en-US" smtClean="0"/>
              <a:t>2022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2A26-D126-4290-B59C-AD18D371CC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375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777C6-8BDF-4582-9500-7DF6310D3978}" type="datetimeFigureOut">
              <a:rPr lang="zh-CN" altLang="en-US" smtClean="0"/>
              <a:t>2022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2A26-D126-4290-B59C-AD18D371CC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6530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777C6-8BDF-4582-9500-7DF6310D3978}" type="datetimeFigureOut">
              <a:rPr lang="zh-CN" altLang="en-US" smtClean="0"/>
              <a:t>2022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2A26-D126-4290-B59C-AD18D371CC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362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777C6-8BDF-4582-9500-7DF6310D3978}" type="datetimeFigureOut">
              <a:rPr lang="zh-CN" altLang="en-US" smtClean="0"/>
              <a:t>2022/3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2A26-D126-4290-B59C-AD18D371CC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8596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777C6-8BDF-4582-9500-7DF6310D3978}" type="datetimeFigureOut">
              <a:rPr lang="zh-CN" altLang="en-US" smtClean="0"/>
              <a:t>2022/3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2A26-D126-4290-B59C-AD18D371CC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26951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777C6-8BDF-4582-9500-7DF6310D3978}" type="datetimeFigureOut">
              <a:rPr lang="zh-CN" altLang="en-US" smtClean="0"/>
              <a:t>2022/3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2A26-D126-4290-B59C-AD18D371CC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3092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777C6-8BDF-4582-9500-7DF6310D3978}" type="datetimeFigureOut">
              <a:rPr lang="zh-CN" altLang="en-US" smtClean="0"/>
              <a:t>2022/3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2A26-D126-4290-B59C-AD18D371CC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67814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777C6-8BDF-4582-9500-7DF6310D3978}" type="datetimeFigureOut">
              <a:rPr lang="zh-CN" altLang="en-US" smtClean="0"/>
              <a:t>2022/3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2A26-D126-4290-B59C-AD18D371CC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4665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E777C6-8BDF-4582-9500-7DF6310D3978}" type="datetimeFigureOut">
              <a:rPr lang="zh-CN" altLang="en-US" smtClean="0"/>
              <a:t>2022/3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2A26-D126-4290-B59C-AD18D371CC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497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E777C6-8BDF-4582-9500-7DF6310D3978}" type="datetimeFigureOut">
              <a:rPr lang="zh-CN" altLang="en-US" smtClean="0"/>
              <a:t>2022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0E2A26-D126-4290-B59C-AD18D371CC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0901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1B10B2BD-1F1D-428F-A33B-1A35CBEA18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5717" y="169120"/>
            <a:ext cx="9860566" cy="516999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7F16B63C-B82B-4853-8FEF-62EC6A38DB1D}"/>
              </a:ext>
            </a:extLst>
          </p:cNvPr>
          <p:cNvSpPr txBox="1"/>
          <p:nvPr/>
        </p:nvSpPr>
        <p:spPr>
          <a:xfrm>
            <a:off x="304738" y="5162179"/>
            <a:ext cx="11748157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kern="100" dirty="0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2.</a:t>
            </a:r>
            <a:r>
              <a:rPr lang="en-US" altLang="zh-CN" sz="1600" kern="100" dirty="0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Differences in TPL concentration over lactation in Chengdu (A), Guangzhou (B), Changchun (C), Lanzhou (D), Shanghai (E) and Tianjin (F). </a:t>
            </a:r>
            <a:br>
              <a:rPr lang="en-US" altLang="zh-CN" sz="1600" kern="100" dirty="0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600" kern="100" dirty="0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PL concentration were expressed as median (inter quartile range, IQR) and Kruskal-Wallis test was conducted to examine the differences of TPL concentration over lactation. </a:t>
            </a:r>
            <a:br>
              <a:rPr lang="en-US" altLang="zh-CN" sz="1600" kern="100" dirty="0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600" kern="100" dirty="0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* indicated significant difference; ns showed no significant difference. </a:t>
            </a:r>
            <a:br>
              <a:rPr lang="en-US" altLang="zh-CN" sz="1600" kern="100" dirty="0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</a:br>
            <a:r>
              <a:rPr lang="en-US" altLang="zh-CN" sz="1600" kern="100" dirty="0"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PL, total phospholipid.</a:t>
            </a:r>
            <a:endParaRPr lang="zh-CN" altLang="zh-CN" sz="1600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96738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82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Palatino Linotype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杨 梦焘</dc:creator>
  <cp:lastModifiedBy>杨 梦焘</cp:lastModifiedBy>
  <cp:revision>1</cp:revision>
  <dcterms:created xsi:type="dcterms:W3CDTF">2022-03-20T13:17:02Z</dcterms:created>
  <dcterms:modified xsi:type="dcterms:W3CDTF">2022-03-20T13:22:26Z</dcterms:modified>
</cp:coreProperties>
</file>